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71" r:id="rId3"/>
    <p:sldId id="272" r:id="rId4"/>
    <p:sldId id="270" r:id="rId5"/>
    <p:sldId id="259" r:id="rId6"/>
    <p:sldId id="267" r:id="rId7"/>
    <p:sldId id="266" r:id="rId8"/>
    <p:sldId id="263" r:id="rId9"/>
    <p:sldId id="265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78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789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9145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2770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9096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748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6474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368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8024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84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4181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2143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F5EE0-E9F2-418F-8012-4205A3FC1910}" type="datetimeFigureOut">
              <a:rPr lang="zh-CN" altLang="en-US" smtClean="0"/>
              <a:t>2021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E55C0-692B-4B65-A042-D6B004033A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4862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536114" y="2878574"/>
            <a:ext cx="6399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MYB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73" b="8918"/>
          <a:stretch/>
        </p:blipFill>
        <p:spPr>
          <a:xfrm>
            <a:off x="2350751" y="263237"/>
            <a:ext cx="7865747" cy="64423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2551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785706" y="3139831"/>
            <a:ext cx="10198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zf-C2H2</a:t>
            </a:r>
            <a:endParaRPr lang="zh-CN" altLang="en-US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11" b="9478"/>
          <a:stretch/>
        </p:blipFill>
        <p:spPr>
          <a:xfrm>
            <a:off x="2537872" y="179515"/>
            <a:ext cx="7536980" cy="62899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1544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470152" y="3059668"/>
            <a:ext cx="7457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bHLH</a:t>
            </a:r>
            <a:endParaRPr lang="zh-CN" altLang="en-US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79" b="8716"/>
          <a:stretch/>
        </p:blipFill>
        <p:spPr>
          <a:xfrm>
            <a:off x="2455480" y="193964"/>
            <a:ext cx="7726617" cy="63038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361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470152" y="3059668"/>
            <a:ext cx="12057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 smtClean="0"/>
              <a:t>Fork_head</a:t>
            </a:r>
            <a:endParaRPr lang="zh-CN" altLang="en-US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40" b="8687"/>
          <a:stretch/>
        </p:blipFill>
        <p:spPr>
          <a:xfrm>
            <a:off x="2546565" y="277090"/>
            <a:ext cx="7098869" cy="5985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43647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18274" y="3059668"/>
            <a:ext cx="7008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HMG</a:t>
            </a:r>
            <a:endParaRPr lang="zh-CN" altLang="en-US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16" b="8178"/>
          <a:stretch/>
        </p:blipFill>
        <p:spPr>
          <a:xfrm>
            <a:off x="2382250" y="30079"/>
            <a:ext cx="8004330" cy="64285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805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785706" y="3139831"/>
            <a:ext cx="6928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ZBTB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44" b="6263"/>
          <a:stretch/>
        </p:blipFill>
        <p:spPr>
          <a:xfrm>
            <a:off x="2401936" y="304800"/>
            <a:ext cx="7388128" cy="61237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75488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122117" y="3066200"/>
            <a:ext cx="9605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TF_bZIP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6770" y="0"/>
            <a:ext cx="679845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0245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635985" y="2982323"/>
            <a:ext cx="5918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PAX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0624" y="0"/>
            <a:ext cx="717075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27391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764542" y="3046605"/>
            <a:ext cx="7873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T-box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1885" y="0"/>
            <a:ext cx="682823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9633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3</Words>
  <Application>Microsoft Office PowerPoint</Application>
  <PresentationFormat>宽屏</PresentationFormat>
  <Paragraphs>9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马艳</dc:creator>
  <cp:lastModifiedBy>马艳</cp:lastModifiedBy>
  <cp:revision>11</cp:revision>
  <dcterms:created xsi:type="dcterms:W3CDTF">2021-05-02T13:40:56Z</dcterms:created>
  <dcterms:modified xsi:type="dcterms:W3CDTF">2021-07-01T14:30:36Z</dcterms:modified>
</cp:coreProperties>
</file>